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6" d="100"/>
          <a:sy n="106" d="100"/>
        </p:scale>
        <p:origin x="-1176" y="-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6267F-2153-48D6-A438-39C8E85663A4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7A11-3CA8-4C29-B319-49E4596F38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10883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6267F-2153-48D6-A438-39C8E85663A4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7A11-3CA8-4C29-B319-49E4596F38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503791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6267F-2153-48D6-A438-39C8E85663A4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7A11-3CA8-4C29-B319-49E4596F38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573344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6267F-2153-48D6-A438-39C8E85663A4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7A11-3CA8-4C29-B319-49E4596F38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6238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6267F-2153-48D6-A438-39C8E85663A4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7A11-3CA8-4C29-B319-49E4596F38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559666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6267F-2153-48D6-A438-39C8E85663A4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7A11-3CA8-4C29-B319-49E4596F38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95108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6267F-2153-48D6-A438-39C8E85663A4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7A11-3CA8-4C29-B319-49E4596F38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32634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6267F-2153-48D6-A438-39C8E85663A4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7A11-3CA8-4C29-B319-49E4596F38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73123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6267F-2153-48D6-A438-39C8E85663A4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7A11-3CA8-4C29-B319-49E4596F38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4205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6267F-2153-48D6-A438-39C8E85663A4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7A11-3CA8-4C29-B319-49E4596F38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498817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96267F-2153-48D6-A438-39C8E85663A4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F77A11-3CA8-4C29-B319-49E4596F38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2965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96267F-2153-48D6-A438-39C8E85663A4}" type="datetimeFigureOut">
              <a:rPr lang="ko-KR" altLang="en-US" smtClean="0"/>
              <a:t>2015-06-1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F77A11-3CA8-4C29-B319-49E4596F38B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7879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116768" y="6309320"/>
            <a:ext cx="727165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/>
              <a:t>Figure S1</a:t>
            </a:r>
            <a:r>
              <a:rPr lang="en-US" altLang="ko-KR" sz="1100" dirty="0"/>
              <a:t>. </a:t>
            </a:r>
            <a:r>
              <a:rPr lang="en-US" altLang="ko-KR" sz="1100" dirty="0" err="1" smtClean="0"/>
              <a:t>Multialignment</a:t>
            </a:r>
            <a:r>
              <a:rPr lang="en-US" altLang="ko-KR" sz="1100" dirty="0" smtClean="0"/>
              <a:t> </a:t>
            </a:r>
            <a:r>
              <a:rPr lang="en-US" altLang="ko-KR" sz="1100" dirty="0"/>
              <a:t>of </a:t>
            </a:r>
            <a:r>
              <a:rPr lang="en-US" altLang="ko-KR" sz="1100" i="1" dirty="0" smtClean="0"/>
              <a:t>BrMYB28</a:t>
            </a:r>
            <a:r>
              <a:rPr lang="en-US" altLang="ko-KR" sz="1100" dirty="0" smtClean="0"/>
              <a:t> genes and </a:t>
            </a:r>
            <a:r>
              <a:rPr lang="en-US" altLang="ko-KR" sz="1100" i="1" dirty="0" smtClean="0"/>
              <a:t>AtMYB28</a:t>
            </a:r>
            <a:r>
              <a:rPr lang="en-US" altLang="ko-KR" sz="1100" dirty="0" smtClean="0"/>
              <a:t> </a:t>
            </a:r>
            <a:r>
              <a:rPr lang="en-US" altLang="ko-KR" sz="1100" dirty="0"/>
              <a:t>which regulating </a:t>
            </a:r>
            <a:r>
              <a:rPr lang="en-US" altLang="ko-KR" sz="1100" dirty="0" err="1"/>
              <a:t>glucosinolate</a:t>
            </a:r>
            <a:r>
              <a:rPr lang="en-US" altLang="ko-KR" sz="1100" dirty="0"/>
              <a:t> biosynthesis pathway of </a:t>
            </a:r>
            <a:r>
              <a:rPr lang="en-US" altLang="ko-KR" sz="1100" i="1" dirty="0" err="1"/>
              <a:t>B.rapa</a:t>
            </a:r>
            <a:r>
              <a:rPr lang="en-US" altLang="ko-KR" sz="1100" i="1" dirty="0"/>
              <a:t> </a:t>
            </a:r>
            <a:r>
              <a:rPr lang="en-US" altLang="ko-KR" sz="1100" dirty="0"/>
              <a:t>and </a:t>
            </a:r>
            <a:r>
              <a:rPr lang="en-US" altLang="ko-KR" sz="1100" i="1" dirty="0" err="1"/>
              <a:t>A.thaliana</a:t>
            </a:r>
            <a:r>
              <a:rPr lang="en-US" altLang="ko-KR" sz="1100" dirty="0"/>
              <a:t>. </a:t>
            </a:r>
            <a:endParaRPr lang="ko-KR" altLang="en-US" sz="1100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617" y="116632"/>
            <a:ext cx="6696744" cy="61926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8989961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9</Words>
  <Application>Microsoft Office PowerPoint</Application>
  <PresentationFormat>화면 슬라이드 쇼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서미숙</dc:creator>
  <cp:lastModifiedBy>서미숙</cp:lastModifiedBy>
  <cp:revision>4</cp:revision>
  <dcterms:created xsi:type="dcterms:W3CDTF">2014-03-20T08:36:30Z</dcterms:created>
  <dcterms:modified xsi:type="dcterms:W3CDTF">2015-06-15T02:09:10Z</dcterms:modified>
</cp:coreProperties>
</file>